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38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ura Smales" initials="MOU" lastIdx="2" clrIdx="0">
    <p:extLst>
      <p:ext uri="{19B8F6BF-5375-455C-9EA6-DF929625EA0E}">
        <p15:presenceInfo xmlns:p15="http://schemas.microsoft.com/office/powerpoint/2012/main" userId="Laura Smale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BDF1"/>
    <a:srgbClr val="F3650D"/>
    <a:srgbClr val="FFCCFF"/>
    <a:srgbClr val="FC8C8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等深淺樣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無樣式、無格線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13" autoAdjust="0"/>
    <p:restoredTop sz="95100" autoAdjust="0"/>
  </p:normalViewPr>
  <p:slideViewPr>
    <p:cSldViewPr snapToGrid="0">
      <p:cViewPr varScale="1">
        <p:scale>
          <a:sx n="62" d="100"/>
          <a:sy n="62" d="100"/>
        </p:scale>
        <p:origin x="2544" y="192"/>
      </p:cViewPr>
      <p:guideLst>
        <p:guide orient="horz" pos="343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45FD07-58D9-4A42-BEBE-21D2A5DB735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83D54B-08D3-4CA1-B41D-8B71E3CAF55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216485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58137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82205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17123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64495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92270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8701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54211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61943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01846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93127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51083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33188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7266391"/>
              </p:ext>
            </p:extLst>
          </p:nvPr>
        </p:nvGraphicFramePr>
        <p:xfrm>
          <a:off x="475823" y="2228240"/>
          <a:ext cx="5917112" cy="2904769"/>
        </p:xfrm>
        <a:graphic>
          <a:graphicData uri="http://schemas.openxmlformats.org/drawingml/2006/table">
            <a:tbl>
              <a:tblPr/>
              <a:tblGrid>
                <a:gridCol w="128069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3807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355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1109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693696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354828">
                <a:tc>
                  <a:txBody>
                    <a:bodyPr/>
                    <a:lstStyle/>
                    <a:p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ngal species</a:t>
                      </a:r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PMingLiU"/>
                          <a:cs typeface="Times New Roman" panose="02020603050405020304" pitchFamily="18" charset="0"/>
                        </a:rPr>
                        <a:t>Optimal temperature (</a:t>
                      </a:r>
                      <a:r>
                        <a:rPr lang="en-US" sz="105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°</a:t>
                      </a:r>
                      <a:r>
                        <a:rPr lang="en-US" sz="105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PMingLiU"/>
                          <a:cs typeface="Times New Roman" panose="02020603050405020304" pitchFamily="18" charset="0"/>
                        </a:rPr>
                        <a:t>C)</a:t>
                      </a:r>
                    </a:p>
                  </a:txBody>
                  <a:tcPr marL="42779" marR="42779" marT="0" marB="0" anchor="ctr">
                    <a:lnL w="12700" cmpd="sng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PMingLiU"/>
                          <a:cs typeface="Times New Roman" panose="02020603050405020304" pitchFamily="18" charset="0"/>
                        </a:rPr>
                        <a:t>Optimal pH</a:t>
                      </a: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PMingLiU"/>
                          <a:cs typeface="Times New Roman" panose="02020603050405020304" pitchFamily="18" charset="0"/>
                        </a:rPr>
                        <a:t>Optimal shake speed (rpm)</a:t>
                      </a: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ural Medium</a:t>
                      </a:r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06838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000" i="1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Aspergillus </a:t>
                      </a:r>
                      <a:r>
                        <a:rPr lang="en-US" sz="1000" i="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sp. </a:t>
                      </a: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RS-19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35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7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150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MR(-P-N) + 0.5% (NH</a:t>
                      </a:r>
                      <a:r>
                        <a:rPr lang="en-US" sz="1000" kern="0" baseline="-250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4</a:t>
                      </a:r>
                      <a:r>
                        <a:rPr lang="en-US" sz="1000" kern="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)</a:t>
                      </a:r>
                      <a:r>
                        <a:rPr lang="en-US" sz="1000" kern="0" baseline="-250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2</a:t>
                      </a:r>
                      <a:r>
                        <a:rPr lang="en-US" sz="1000" kern="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HPO</a:t>
                      </a:r>
                      <a:r>
                        <a:rPr lang="en-US" sz="1000" kern="0" baseline="-250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4 </a:t>
                      </a:r>
                      <a:r>
                        <a:rPr lang="en-US" sz="1000" kern="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+ 5% Napier grass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5514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kern="100" dirty="0" err="1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Chaetomella</a:t>
                      </a:r>
                      <a:r>
                        <a:rPr lang="en-US" sz="1000" i="1" kern="100" baseline="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 </a:t>
                      </a:r>
                      <a:r>
                        <a:rPr lang="en-US" sz="1000" i="1" kern="100" baseline="0" dirty="0" err="1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raphigera</a:t>
                      </a:r>
                      <a:r>
                        <a:rPr lang="en-US" sz="1000" i="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 </a:t>
                      </a: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D2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30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5</a:t>
                      </a:r>
                      <a:endParaRPr lang="en-US" sz="1000" kern="10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125</a:t>
                      </a:r>
                      <a:endParaRPr lang="en-US" sz="1000" kern="10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MR + cellobiose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97563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kern="100" dirty="0" err="1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Daldinia</a:t>
                      </a:r>
                      <a:r>
                        <a:rPr lang="en-US" sz="1000" b="0" i="1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 </a:t>
                      </a:r>
                      <a:r>
                        <a:rPr lang="en-US" sz="1000" b="0" i="1" kern="100" dirty="0" err="1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caldariorum</a:t>
                      </a:r>
                      <a:r>
                        <a:rPr lang="en-US" sz="1000" b="0" i="1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 </a:t>
                      </a:r>
                      <a:r>
                        <a:rPr lang="en-US" sz="1000" b="0" i="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 D</a:t>
                      </a:r>
                      <a:r>
                        <a:rPr lang="en-US" sz="1000" b="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263</a:t>
                      </a:r>
                      <a:endParaRPr lang="en-US" sz="1000" b="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35</a:t>
                      </a:r>
                      <a:endParaRPr lang="en-US" sz="1000" b="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7</a:t>
                      </a:r>
                      <a:endParaRPr lang="en-US" sz="1000" b="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125</a:t>
                      </a:r>
                      <a:endParaRPr lang="en-US" sz="1000" b="0" kern="10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MR + 1% filter paper</a:t>
                      </a:r>
                      <a:endParaRPr lang="en-US" sz="1000" b="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97563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Fusarium </a:t>
                      </a:r>
                      <a:r>
                        <a:rPr lang="en-US" sz="1000" i="1" kern="100" dirty="0" err="1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proliferatum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40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5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150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MR(-P) + 1% α-cellulose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97563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kern="100" dirty="0" err="1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Neurospora</a:t>
                      </a:r>
                      <a:r>
                        <a:rPr lang="en-US" sz="1000" i="1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 </a:t>
                      </a:r>
                      <a:r>
                        <a:rPr lang="en-US" sz="1000" i="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sp.</a:t>
                      </a: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 RS-6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25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7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150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MR(-P) + 3% Napier grass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97563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kern="100" dirty="0" err="1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Penicillium</a:t>
                      </a:r>
                      <a:r>
                        <a:rPr lang="en-US" sz="1000" i="1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 </a:t>
                      </a:r>
                      <a:r>
                        <a:rPr lang="en-US" sz="1000" i="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sp.</a:t>
                      </a: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 YS40-5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30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5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125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MR + </a:t>
                      </a:r>
                      <a:r>
                        <a:rPr lang="en-US" sz="1000" kern="100" dirty="0" err="1">
                          <a:solidFill>
                            <a:schemeClr val="tx1"/>
                          </a:solidFill>
                          <a:latin typeface="Times New Roman"/>
                          <a:ea typeface="DFKai-SB"/>
                          <a:cs typeface="Times New Roman"/>
                        </a:rPr>
                        <a:t>cellobiose</a:t>
                      </a:r>
                      <a:endParaRPr lang="en-US" sz="1000" kern="100" dirty="0">
                        <a:solidFill>
                          <a:schemeClr val="tx1"/>
                        </a:solidFill>
                        <a:latin typeface="Times New Roman"/>
                        <a:ea typeface="PMingLiU"/>
                        <a:cs typeface="Times New Roman"/>
                      </a:endParaRPr>
                    </a:p>
                  </a:txBody>
                  <a:tcPr marL="42779" marR="4277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3" name="文字方塊 2"/>
          <p:cNvSpPr txBox="1"/>
          <p:nvPr/>
        </p:nvSpPr>
        <p:spPr>
          <a:xfrm>
            <a:off x="415640" y="5837728"/>
            <a:ext cx="5988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latin typeface="Times New Roman" pitchFamily="18" charset="0"/>
                <a:cs typeface="Times New Roman" pitchFamily="18" charset="0"/>
              </a:rPr>
              <a:t>Table S1. 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Optimal growth conditions for the </a:t>
            </a:r>
            <a:r>
              <a:rPr lang="en-US" altLang="zh-TW" sz="1200" dirty="0" err="1">
                <a:latin typeface="Times New Roman" pitchFamily="18" charset="0"/>
                <a:cs typeface="Times New Roman" pitchFamily="18" charset="0"/>
              </a:rPr>
              <a:t>ascomycetes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 tested.</a:t>
            </a:r>
            <a:endParaRPr lang="zh-TW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id="{D84D55FA-C7C2-44BD-B02E-ED574C5E16F6}"/>
              </a:ext>
            </a:extLst>
          </p:cNvPr>
          <p:cNvSpPr txBox="1"/>
          <p:nvPr/>
        </p:nvSpPr>
        <p:spPr>
          <a:xfrm>
            <a:off x="2682240" y="14516"/>
            <a:ext cx="1158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Times New Roman" pitchFamily="18" charset="0"/>
                <a:cs typeface="Times New Roman" pitchFamily="18" charset="0"/>
              </a:rPr>
              <a:t>Table S1</a:t>
            </a:r>
            <a:endParaRPr lang="zh-TW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FB67EAD-B11A-724A-8F64-0704F7210937}"/>
              </a:ext>
            </a:extLst>
          </p:cNvPr>
          <p:cNvSpPr txBox="1"/>
          <p:nvPr/>
        </p:nvSpPr>
        <p:spPr>
          <a:xfrm>
            <a:off x="4966855" y="8562109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718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62</TotalTime>
  <Words>111</Words>
  <Application>Microsoft Macintosh PowerPoint</Application>
  <PresentationFormat>A4 Paper (210x297 mm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DFKai-SB</vt:lpstr>
      <vt:lpstr>PMingLiU</vt:lpstr>
      <vt:lpstr>PMingLiU</vt:lpstr>
      <vt:lpstr>Arial</vt:lpstr>
      <vt:lpstr>Calibri</vt:lpstr>
      <vt:lpstr>Calibri Light</vt:lpstr>
      <vt:lpstr>Times New Roman</vt:lpstr>
      <vt:lpstr>Office 佈景主題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Windows 使用者</dc:creator>
  <cp:lastModifiedBy>Microsoft Office User</cp:lastModifiedBy>
  <cp:revision>480</cp:revision>
  <dcterms:created xsi:type="dcterms:W3CDTF">2018-04-06T13:08:10Z</dcterms:created>
  <dcterms:modified xsi:type="dcterms:W3CDTF">2021-03-09T16:45:13Z</dcterms:modified>
</cp:coreProperties>
</file>